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38" d="100"/>
          <a:sy n="138" d="100"/>
        </p:scale>
        <p:origin x="-104" y="-26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AU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C517C-96A8-7244-B1E9-3AF804E4A3DD}" type="datetimeFigureOut">
              <a:rPr lang="en-US" smtClean="0"/>
              <a:t>6/06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55A9B-4D8F-1C4C-A6CA-172AA8AF0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84276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C517C-96A8-7244-B1E9-3AF804E4A3DD}" type="datetimeFigureOut">
              <a:rPr lang="en-US" smtClean="0"/>
              <a:t>6/06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55A9B-4D8F-1C4C-A6CA-172AA8AF0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83338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C517C-96A8-7244-B1E9-3AF804E4A3DD}" type="datetimeFigureOut">
              <a:rPr lang="en-US" smtClean="0"/>
              <a:t>6/06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55A9B-4D8F-1C4C-A6CA-172AA8AF0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1251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C517C-96A8-7244-B1E9-3AF804E4A3DD}" type="datetimeFigureOut">
              <a:rPr lang="en-US" smtClean="0"/>
              <a:t>6/06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55A9B-4D8F-1C4C-A6CA-172AA8AF0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25135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C517C-96A8-7244-B1E9-3AF804E4A3DD}" type="datetimeFigureOut">
              <a:rPr lang="en-US" smtClean="0"/>
              <a:t>6/06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55A9B-4D8F-1C4C-A6CA-172AA8AF0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61694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C517C-96A8-7244-B1E9-3AF804E4A3DD}" type="datetimeFigureOut">
              <a:rPr lang="en-US" smtClean="0"/>
              <a:t>6/06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55A9B-4D8F-1C4C-A6CA-172AA8AF0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13156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C517C-96A8-7244-B1E9-3AF804E4A3DD}" type="datetimeFigureOut">
              <a:rPr lang="en-US" smtClean="0"/>
              <a:t>6/06/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55A9B-4D8F-1C4C-A6CA-172AA8AF0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76301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C517C-96A8-7244-B1E9-3AF804E4A3DD}" type="datetimeFigureOut">
              <a:rPr lang="en-US" smtClean="0"/>
              <a:t>6/06/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55A9B-4D8F-1C4C-A6CA-172AA8AF0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1257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C517C-96A8-7244-B1E9-3AF804E4A3DD}" type="datetimeFigureOut">
              <a:rPr lang="en-US" smtClean="0"/>
              <a:t>6/06/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55A9B-4D8F-1C4C-A6CA-172AA8AF0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99864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C517C-96A8-7244-B1E9-3AF804E4A3DD}" type="datetimeFigureOut">
              <a:rPr lang="en-US" smtClean="0"/>
              <a:t>6/06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55A9B-4D8F-1C4C-A6CA-172AA8AF0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46804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C517C-96A8-7244-B1E9-3AF804E4A3DD}" type="datetimeFigureOut">
              <a:rPr lang="en-US" smtClean="0"/>
              <a:t>6/06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55A9B-4D8F-1C4C-A6CA-172AA8AF0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92512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0C517C-96A8-7244-B1E9-3AF804E4A3DD}" type="datetimeFigureOut">
              <a:rPr lang="en-US" smtClean="0"/>
              <a:t>6/06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455A9B-4D8F-1C4C-A6CA-172AA8AF0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97703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Screen shot 2012-06-06 at 10.20.53 PM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5924" y="1289710"/>
            <a:ext cx="7696200" cy="51689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791498" y="1510415"/>
            <a:ext cx="13085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m</a:t>
            </a:r>
            <a:r>
              <a:rPr lang="en-US" b="1" dirty="0" smtClean="0"/>
              <a:t>ouse LIPH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2287568" y="2024502"/>
            <a:ext cx="2518638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r</a:t>
            </a:r>
            <a:r>
              <a:rPr lang="en-US" sz="1400" b="1" dirty="0" smtClean="0"/>
              <a:t>esidues 147-167</a:t>
            </a:r>
          </a:p>
          <a:p>
            <a:r>
              <a:rPr lang="en-US" sz="1400" b="1" dirty="0"/>
              <a:t>p</a:t>
            </a:r>
            <a:r>
              <a:rPr lang="en-US" sz="1400" b="1" dirty="0" smtClean="0"/>
              <a:t>redicted phospholipid binding </a:t>
            </a:r>
          </a:p>
          <a:p>
            <a:r>
              <a:rPr lang="en-US" sz="1400" b="1" dirty="0"/>
              <a:t>s</a:t>
            </a:r>
            <a:r>
              <a:rPr lang="en-US" sz="1400" b="1" dirty="0" smtClean="0"/>
              <a:t>ite near active site </a:t>
            </a:r>
          </a:p>
          <a:p>
            <a:r>
              <a:rPr lang="en-US" sz="1400" b="1" dirty="0"/>
              <a:t> </a:t>
            </a:r>
            <a:r>
              <a:rPr lang="en-US" sz="1400" b="1" dirty="0" smtClean="0"/>
              <a:t>                 |      |</a:t>
            </a:r>
            <a:endParaRPr lang="en-US" sz="14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3340568" y="6464232"/>
            <a:ext cx="19720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a</a:t>
            </a:r>
            <a:r>
              <a:rPr lang="en-US" sz="1600" b="1" dirty="0" smtClean="0"/>
              <a:t>mino acid sequence</a:t>
            </a:r>
            <a:endParaRPr 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19275150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9</Words>
  <Application>Microsoft Macintosh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OM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ger Holmes</dc:creator>
  <cp:lastModifiedBy>Roger Holmes</cp:lastModifiedBy>
  <cp:revision>2</cp:revision>
  <dcterms:created xsi:type="dcterms:W3CDTF">2012-06-06T12:20:33Z</dcterms:created>
  <dcterms:modified xsi:type="dcterms:W3CDTF">2012-06-06T12:29:27Z</dcterms:modified>
</cp:coreProperties>
</file>